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1243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7035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4313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7148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029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6783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3706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7709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4797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8344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3541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E38EE-F141-4C1A-8974-5E5C34E99CE2}" type="datetimeFigureOut">
              <a:rPr lang="ko-KR" altLang="en-US" smtClean="0"/>
              <a:t>2023-05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7D9A7-3D5A-4170-964C-D396E60C0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698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1155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. Fosfomycin versus fluoroquinolone; Febrile urinary tract infection. [6,16,17,30,31,32-35]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2594" y="1374198"/>
            <a:ext cx="8153400" cy="3943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92689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019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0. Fosfomycin + fluoroquinolone versus fluoroquinolone; Positive blood culture. [38,39]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3341" y="1912360"/>
            <a:ext cx="10020300" cy="1952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57660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23454" y="648391"/>
            <a:ext cx="7247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1. Fosfomycin + fluoroquinolone versus fluoroquinolone; Fluoroquinolone resistance.[38,39]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1303" y="1754418"/>
            <a:ext cx="10001250" cy="1952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422842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7626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2. Fosfomycin versus b-lactam or fluoroquinolone; Febrile urinary tract infection.[37]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6656" y="1470399"/>
            <a:ext cx="8915400" cy="1190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13471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095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3. Fosfomycin versus fluoroquinolone + metronidazole; Febrile urinary tract infection.[16] 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2918" y="1430048"/>
            <a:ext cx="10010775" cy="1171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82245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160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4. Fosfomycin versus fluoroquinolone + metronidazole; Afebrile urinary tract infection.[16] 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4909" y="2085541"/>
            <a:ext cx="10306050" cy="1190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205958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111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5. Fosfomycin versus fluoroquinolone + metronidazole; Overall urinary tract infection.[16] </a:t>
            </a: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6568" y="1782733"/>
            <a:ext cx="9753600" cy="1181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887815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5477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6. Fosfomycin versus fluoroquinolone + metronidazole; Drug adverse events. [16]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5777" y="1529801"/>
            <a:ext cx="9782175" cy="1171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847097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566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7. Fosfomycin versus fluoroquinolone + metronidazole; Positive urine culture.[16]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8801" y="1699606"/>
            <a:ext cx="9763125" cy="1181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775955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940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8. Fosfomycin versus fluoroquinolone + metronidazole; Fluoroquinolone resistance.[16]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454" y="1653280"/>
            <a:ext cx="9906000" cy="1190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527613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8012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19. Fosfomycin versus fluoroquinolone + metronidazole + gentamycin; Overall urinary tract infection.  [36]</a:t>
            </a: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1563052"/>
            <a:ext cx="9906000" cy="1171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58297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367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2. Fosfomycin versus fluoroquinolone; Afebrile urinary tract infection. [6,16,17,30,31,32,33,34]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8697" y="1230716"/>
            <a:ext cx="8162925" cy="3781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07319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2718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3. Fosfomycin versus fluoroquinolone; Overall urinary tract infection. [6,16,17,30,31,32,33,34]</a:t>
            </a: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223831E2-0915-7168-187C-4043134806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7014" y="1459160"/>
            <a:ext cx="8115300" cy="3771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34826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57305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4. Fosfomycin versus fluoroquinolone; Drug adverse events.[6,30,31] 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8027" y="1538114"/>
            <a:ext cx="8153400" cy="3000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37210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336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5. Fosfomycin versus fluoroquinolone; Positive urine culture.[6,17,30,31,33,34]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2666" y="1535170"/>
            <a:ext cx="8143875" cy="3438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18255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0555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6. Fosfomycin versus fluoroquinolone; Positive blood culture.[6,33,34,35]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7357" y="1739785"/>
            <a:ext cx="8172450" cy="3162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52925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7095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7. Fosfomycin versus fluoroquinolone; Fluoroquinolone resistance.[6,17,30,31,33,34]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0927" y="1329690"/>
            <a:ext cx="8134350" cy="3467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98348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7401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8. Fosfomycin + fluoroquinolone versus fluoroquinolone; Febrile urinary tract infection. [38,39]</a:t>
            </a:r>
          </a:p>
        </p:txBody>
      </p:sp>
      <p:grpSp>
        <p:nvGrpSpPr>
          <p:cNvPr id="6" name="그룹 5"/>
          <p:cNvGrpSpPr/>
          <p:nvPr/>
        </p:nvGrpSpPr>
        <p:grpSpPr>
          <a:xfrm>
            <a:off x="957609" y="1715279"/>
            <a:ext cx="10010775" cy="1992197"/>
            <a:chOff x="957609" y="1715279"/>
            <a:chExt cx="10010775" cy="1992197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7609" y="1715279"/>
              <a:ext cx="10010775" cy="1914525"/>
            </a:xfrm>
            <a:prstGeom prst="rect">
              <a:avLst/>
            </a:prstGeom>
          </p:spPr>
        </p:pic>
        <p:sp>
          <p:nvSpPr>
            <p:cNvPr id="5" name="직사각형 4"/>
            <p:cNvSpPr/>
            <p:nvPr/>
          </p:nvSpPr>
          <p:spPr>
            <a:xfrm>
              <a:off x="957609" y="3516284"/>
              <a:ext cx="2467235" cy="1911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9536324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3454" y="648391"/>
            <a:ext cx="6907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Calibri" panose="020F0502020204030204" pitchFamily="34" charset="0"/>
                <a:cs typeface="Calibri" panose="020F0502020204030204" pitchFamily="34" charset="0"/>
              </a:rPr>
              <a:t>Supplement Figure S9. Fosfomycin + fluoroquinolone versus fluoroquinolone; Positive urine culture.[38,39]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0090" y="1740217"/>
            <a:ext cx="10020300" cy="1914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0185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305</Words>
  <Application>Microsoft Office PowerPoint</Application>
  <PresentationFormat>Widescreen</PresentationFormat>
  <Paragraphs>19</Paragraphs>
  <Slides>1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3" baseType="lpstr">
      <vt:lpstr>맑은 고딕</vt:lpstr>
      <vt:lpstr>Arial</vt:lpstr>
      <vt:lpstr>Calibri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Elosie Tang</cp:lastModifiedBy>
  <cp:revision>40</cp:revision>
  <dcterms:created xsi:type="dcterms:W3CDTF">2020-04-04T06:40:13Z</dcterms:created>
  <dcterms:modified xsi:type="dcterms:W3CDTF">2023-05-10T01:49:52Z</dcterms:modified>
</cp:coreProperties>
</file>